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89" r:id="rId3"/>
    <p:sldId id="291" r:id="rId4"/>
    <p:sldId id="262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27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149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531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794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283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71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626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051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172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188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9595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4343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B9E93-4555-468E-9F07-2C08BCBD7197}" type="datetimeFigureOut">
              <a:rPr kumimoji="1" lang="ja-JP" altLang="en-US" smtClean="0"/>
              <a:t>2022/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57225-2D86-4B58-BA1C-EA12802CBB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069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image" Target="../media/image2.png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649507" y="779929"/>
            <a:ext cx="5020234" cy="4073037"/>
            <a:chOff x="1219200" y="613921"/>
            <a:chExt cx="7616640" cy="5724126"/>
          </a:xfrm>
        </p:grpSpPr>
        <p:grpSp>
          <p:nvGrpSpPr>
            <p:cNvPr id="9" name="グループ化 8"/>
            <p:cNvGrpSpPr/>
            <p:nvPr/>
          </p:nvGrpSpPr>
          <p:grpSpPr>
            <a:xfrm>
              <a:off x="1219200" y="613921"/>
              <a:ext cx="7616640" cy="5724126"/>
              <a:chOff x="762000" y="1788297"/>
              <a:chExt cx="10198994" cy="7889558"/>
            </a:xfrm>
          </p:grpSpPr>
          <p:pic>
            <p:nvPicPr>
              <p:cNvPr id="3" name="コンテンツ プレースホルダー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1788297"/>
                <a:ext cx="5181600" cy="3886200"/>
              </a:xfrm>
              <a:prstGeom prst="rect">
                <a:avLst/>
              </a:prstGeom>
            </p:spPr>
          </p:pic>
          <p:pic>
            <p:nvPicPr>
              <p:cNvPr id="4" name="コンテンツ プレースホルダー 4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000" y="5791655"/>
                <a:ext cx="5181601" cy="3886200"/>
              </a:xfrm>
              <a:prstGeom prst="rect">
                <a:avLst/>
              </a:prstGeom>
            </p:spPr>
          </p:pic>
          <p:cxnSp>
            <p:nvCxnSpPr>
              <p:cNvPr id="5" name="直線コネクタ 4"/>
              <p:cNvCxnSpPr/>
              <p:nvPr/>
            </p:nvCxnSpPr>
            <p:spPr>
              <a:xfrm>
                <a:off x="10175383" y="5242261"/>
                <a:ext cx="785611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直線コネクタ 5"/>
              <p:cNvCxnSpPr/>
              <p:nvPr/>
            </p:nvCxnSpPr>
            <p:spPr>
              <a:xfrm>
                <a:off x="4661148" y="5242261"/>
                <a:ext cx="1045649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" name="直線コネクタ 9"/>
            <p:cNvCxnSpPr/>
            <p:nvPr/>
          </p:nvCxnSpPr>
          <p:spPr>
            <a:xfrm>
              <a:off x="4117491" y="6105129"/>
              <a:ext cx="780894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テキスト ボックス 10"/>
          <p:cNvSpPr txBox="1"/>
          <p:nvPr/>
        </p:nvSpPr>
        <p:spPr>
          <a:xfrm>
            <a:off x="744760" y="223647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639619" y="5327447"/>
            <a:ext cx="1092448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buAutoNum type="alphaUcParenBoth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in image of paclitaxel and neutrophil extracellular traps (NETs). NETs were generated by stimulating neutrophils with 2μM PMA and Oregon green-conjugated paclitaxel (purchased from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sher) were added at the final concentration of 0.2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nd the distribution was observed under fluorescence  microscopy. NETs were visualized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with SYTOX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ange (50nM). Paclitaxel  image was superimposed with bright field image (upper) and NETs image (lower). Bar show 100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</a:p>
          <a:p>
            <a:pPr marL="342900" indent="-342900">
              <a:buAutoNum type="alphaUcParenBoth"/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usion of Paclitaxel. Oregon green-conjugated paclitaxel were placed in the lower chamber at the final concentration of 2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in the presence or absence of neutrophils (5x10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timulated with 2μM PMA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/or 1000u/ml DNAse I. Then, culture inserts with 3</a:t>
            </a:r>
            <a:r>
              <a:rPr lang="en-US" altLang="ja-JP" sz="1200" dirty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pores containing 2mL of HBSS were placed on the bottom chambers. After 1~20 hours, 100μl of medium was collected from the upper chambers and fluorescence intensity measured. Data are shown as mean ± standard deviation in triplicates in one of the 3 different experiments.  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879231" y="650534"/>
            <a:ext cx="668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433646" y="650534"/>
            <a:ext cx="668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オブジェクト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0970812"/>
              </p:ext>
            </p:extLst>
          </p:nvPr>
        </p:nvGraphicFramePr>
        <p:xfrm>
          <a:off x="4612341" y="835200"/>
          <a:ext cx="7050088" cy="4579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53" name="Prism 8" r:id="rId7" imgW="7049657" imgH="4580079" progId="Prism8.Document">
                  <p:embed/>
                </p:oleObj>
              </mc:Choice>
              <mc:Fallback>
                <p:oleObj name="Prism 8" r:id="rId7" imgW="7049657" imgH="4580079" progId="Prism8.Document">
                  <p:embed/>
                  <p:pic>
                    <p:nvPicPr>
                      <p:cNvPr id="4" name="オブジェクト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12341" y="835200"/>
                        <a:ext cx="7050088" cy="4579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22947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861748" y="1149082"/>
            <a:ext cx="513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845003" y="1024902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6647" y="2165536"/>
            <a:ext cx="3358356" cy="252692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3579183-E66E-4F84-ABB5-4E6995063461}"/>
              </a:ext>
            </a:extLst>
          </p:cNvPr>
          <p:cNvSpPr txBox="1"/>
          <p:nvPr/>
        </p:nvSpPr>
        <p:spPr>
          <a:xfrm>
            <a:off x="653725" y="527821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5EF2B86-2AB2-4755-9BB7-77B2A225D726}"/>
              </a:ext>
            </a:extLst>
          </p:cNvPr>
          <p:cNvSpPr txBox="1"/>
          <p:nvPr/>
        </p:nvSpPr>
        <p:spPr>
          <a:xfrm>
            <a:off x="1535502" y="5140600"/>
            <a:ext cx="8941998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Apoptosis assay with collagen gel droplet-embedded culture. (A) KOC-2S (1×106) were embedded in collagen gel and dropped in 6 well plates as 5 spots each with a volume of 30μl as described in Materials and Methods. (B) The droplets were filled with DMEM supplemented with 2% FBS with or without PMA- or LPS-stimulated neutrophils (5x106). After 20 hours, the wells were washed and collagen gel digested with collagenase and recovered cells were stained with FITC-conjugated annexin V and 7-AAD. In tumor cell population gated in flowcytometric profile (</a:t>
            </a:r>
            <a:r>
              <a:rPr lang="en-US" altLang="ja-JP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FSCxSCC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), ratios of annexin V (+) apoptotic cells were calculated. Numbers show the percentages of annexin V (+) tumor cells. 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66FBD4A-DD0E-4A9F-B6C1-F0A9772CDB87}"/>
              </a:ext>
            </a:extLst>
          </p:cNvPr>
          <p:cNvSpPr txBox="1"/>
          <p:nvPr/>
        </p:nvSpPr>
        <p:spPr>
          <a:xfrm>
            <a:off x="3548896" y="1336658"/>
            <a:ext cx="20030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DMEM+2%FCS</a:t>
            </a:r>
          </a:p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Neutrophils</a:t>
            </a:r>
          </a:p>
        </p:txBody>
      </p:sp>
      <p:sp>
        <p:nvSpPr>
          <p:cNvPr id="10" name="矢印: 下 9">
            <a:extLst>
              <a:ext uri="{FF2B5EF4-FFF2-40B4-BE49-F238E27FC236}">
                <a16:creationId xmlns:a16="http://schemas.microsoft.com/office/drawing/2014/main" id="{435C7B59-3662-4161-9AB4-A8CD385524EA}"/>
              </a:ext>
            </a:extLst>
          </p:cNvPr>
          <p:cNvSpPr/>
          <p:nvPr/>
        </p:nvSpPr>
        <p:spPr>
          <a:xfrm>
            <a:off x="3908650" y="1930458"/>
            <a:ext cx="514350" cy="891306"/>
          </a:xfrm>
          <a:prstGeom prst="downArrow">
            <a:avLst>
              <a:gd name="adj1" fmla="val 21577"/>
              <a:gd name="adj2" fmla="val 50000"/>
            </a:avLst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30492" y="1123868"/>
            <a:ext cx="3879421" cy="4027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714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F94708F-FBE5-FA6C-D098-A39BB3F68D4B}"/>
              </a:ext>
            </a:extLst>
          </p:cNvPr>
          <p:cNvSpPr txBox="1"/>
          <p:nvPr/>
        </p:nvSpPr>
        <p:spPr>
          <a:xfrm>
            <a:off x="901375" y="546871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731181AF-EB38-4C0F-3D35-200BB159ED9D}"/>
              </a:ext>
            </a:extLst>
          </p:cNvPr>
          <p:cNvGrpSpPr/>
          <p:nvPr/>
        </p:nvGrpSpPr>
        <p:grpSpPr>
          <a:xfrm>
            <a:off x="2573320" y="1301243"/>
            <a:ext cx="6446855" cy="4045457"/>
            <a:chOff x="1116309" y="1019889"/>
            <a:chExt cx="6446855" cy="4045457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E9150E3B-5C5C-4B1C-0463-E3F6A389D92F}"/>
                </a:ext>
              </a:extLst>
            </p:cNvPr>
            <p:cNvGrpSpPr/>
            <p:nvPr/>
          </p:nvGrpSpPr>
          <p:grpSpPr>
            <a:xfrm>
              <a:off x="1116309" y="1019889"/>
              <a:ext cx="6446855" cy="4045457"/>
              <a:chOff x="1628775" y="1443297"/>
              <a:chExt cx="6446855" cy="4045457"/>
            </a:xfrm>
          </p:grpSpPr>
          <p:graphicFrame>
            <p:nvGraphicFramePr>
              <p:cNvPr id="20" name="オブジェクト 19">
                <a:extLst>
                  <a:ext uri="{FF2B5EF4-FFF2-40B4-BE49-F238E27FC236}">
                    <a16:creationId xmlns:a16="http://schemas.microsoft.com/office/drawing/2014/main" id="{6893B225-27CD-8217-FE53-D6F2D2D2E1E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94931351"/>
                  </p:ext>
                </p:extLst>
              </p:nvPr>
            </p:nvGraphicFramePr>
            <p:xfrm>
              <a:off x="1628775" y="1882775"/>
              <a:ext cx="3352800" cy="36052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134" name="Prism 8" r:id="rId3" imgW="3352503" imgH="3605862" progId="Prism8.Document">
                      <p:embed/>
                    </p:oleObj>
                  </mc:Choice>
                  <mc:Fallback>
                    <p:oleObj name="Prism 8" r:id="rId3" imgW="3352503" imgH="3605862" progId="Prism8.Document">
                      <p:embed/>
                      <p:pic>
                        <p:nvPicPr>
                          <p:cNvPr id="2" name="オブジェクト 1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628775" y="1882775"/>
                            <a:ext cx="3352800" cy="36052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1" name="オブジェクト 20">
                <a:extLst>
                  <a:ext uri="{FF2B5EF4-FFF2-40B4-BE49-F238E27FC236}">
                    <a16:creationId xmlns:a16="http://schemas.microsoft.com/office/drawing/2014/main" id="{91DF6788-2582-CA5E-35FB-25F0D246B39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83765913"/>
                  </p:ext>
                </p:extLst>
              </p:nvPr>
            </p:nvGraphicFramePr>
            <p:xfrm>
              <a:off x="4802205" y="1883542"/>
              <a:ext cx="3273425" cy="36052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135" name="Prism 8" r:id="rId5" imgW="3273274" imgH="3605862" progId="Prism8.Document">
                      <p:embed/>
                    </p:oleObj>
                  </mc:Choice>
                  <mc:Fallback>
                    <p:oleObj name="Prism 8" r:id="rId5" imgW="3273274" imgH="3605862" progId="Prism8.Document">
                      <p:embed/>
                      <p:pic>
                        <p:nvPicPr>
                          <p:cNvPr id="4" name="オブジェクト 3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4802205" y="1883542"/>
                            <a:ext cx="3273425" cy="360521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EF46276F-F34B-27C1-6CFD-2C660789A465}"/>
                  </a:ext>
                </a:extLst>
              </p:cNvPr>
              <p:cNvSpPr txBox="1"/>
              <p:nvPr/>
            </p:nvSpPr>
            <p:spPr>
              <a:xfrm>
                <a:off x="2944259" y="1443297"/>
                <a:ext cx="13917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X (5</a:t>
                </a:r>
                <a:r>
                  <a:rPr kumimoji="1" lang="en-US" altLang="ja-JP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m</a:t>
                </a:r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)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5542FD93-0367-347E-D916-1AE7E64C1756}"/>
                  </a:ext>
                </a:extLst>
              </p:cNvPr>
              <p:cNvSpPr txBox="1"/>
              <p:nvPr/>
            </p:nvSpPr>
            <p:spPr>
              <a:xfrm>
                <a:off x="5966925" y="1443297"/>
                <a:ext cx="13500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OX (1</a:t>
                </a:r>
                <a:r>
                  <a:rPr kumimoji="1" lang="en-US" altLang="ja-JP" dirty="0">
                    <a:latin typeface="Symbol" panose="05050102010706020507" pitchFamily="18" charset="2"/>
                    <a:cs typeface="Times New Roman" panose="02020603050405020304" pitchFamily="18" charset="0"/>
                  </a:rPr>
                  <a:t>m</a:t>
                </a:r>
                <a:r>
                  <a:rPr kumimoji="1"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)</a:t>
                </a:r>
                <a:endParaRPr kumimoji="1"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04BCF444-0061-CB4D-EAB8-4C7731CBE1C0}"/>
                </a:ext>
              </a:extLst>
            </p:cNvPr>
            <p:cNvCxnSpPr>
              <a:cxnSpLocks/>
            </p:cNvCxnSpPr>
            <p:nvPr/>
          </p:nvCxnSpPr>
          <p:spPr>
            <a:xfrm>
              <a:off x="5610640" y="2062743"/>
              <a:ext cx="137874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D0207BDE-F784-24BD-5C06-079F10BE3AFE}"/>
                </a:ext>
              </a:extLst>
            </p:cNvPr>
            <p:cNvSpPr txBox="1"/>
            <p:nvPr/>
          </p:nvSpPr>
          <p:spPr>
            <a:xfrm>
              <a:off x="5766094" y="1678438"/>
              <a:ext cx="8675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Calibri" panose="020F0502020204030204" pitchFamily="34" charset="0"/>
                  <a:cs typeface="Calibri" panose="020F0502020204030204" pitchFamily="34" charset="0"/>
                </a:rPr>
                <a:t>P=0.570</a:t>
              </a:r>
              <a:endParaRPr kumimoji="1" lang="ja-JP" altLang="en-US" sz="16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CC5F7851-FF0F-FCC4-6DA0-0953FABB02B6}"/>
                </a:ext>
              </a:extLst>
            </p:cNvPr>
            <p:cNvSpPr txBox="1"/>
            <p:nvPr/>
          </p:nvSpPr>
          <p:spPr>
            <a:xfrm>
              <a:off x="2870803" y="2038735"/>
              <a:ext cx="7633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Calibri" panose="020F0502020204030204" pitchFamily="34" charset="0"/>
                  <a:cs typeface="Calibri" panose="020F0502020204030204" pitchFamily="34" charset="0"/>
                </a:rPr>
                <a:t>P=0.13</a:t>
              </a:r>
              <a:endParaRPr kumimoji="1" lang="ja-JP" altLang="en-US" sz="16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CE59750A-3F73-CD07-BACC-07A539DC80E1}"/>
                </a:ext>
              </a:extLst>
            </p:cNvPr>
            <p:cNvCxnSpPr/>
            <p:nvPr/>
          </p:nvCxnSpPr>
          <p:spPr>
            <a:xfrm>
              <a:off x="2714891" y="2406020"/>
              <a:ext cx="109527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330DA186-518D-5E1E-493D-053EF7CB4462}"/>
              </a:ext>
            </a:extLst>
          </p:cNvPr>
          <p:cNvCxnSpPr/>
          <p:nvPr/>
        </p:nvCxnSpPr>
        <p:spPr>
          <a:xfrm>
            <a:off x="3809367" y="2116192"/>
            <a:ext cx="14578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EA98CFD-47AE-CBD1-34A7-9E320CC45F6C}"/>
              </a:ext>
            </a:extLst>
          </p:cNvPr>
          <p:cNvSpPr txBox="1"/>
          <p:nvPr/>
        </p:nvSpPr>
        <p:spPr>
          <a:xfrm>
            <a:off x="4156594" y="1771499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P&lt;0.01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23D6ADF-9782-BDBF-9940-A971F3D4076A}"/>
              </a:ext>
            </a:extLst>
          </p:cNvPr>
          <p:cNvSpPr txBox="1"/>
          <p:nvPr/>
        </p:nvSpPr>
        <p:spPr>
          <a:xfrm>
            <a:off x="2872443" y="5501616"/>
            <a:ext cx="6481282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PH of HBSS without phenol red was adjusted to 5.6 to 7.6 using 1mol/L Hydrochloric acid. DOX was dissolved in those media at the concentration of 1</a:t>
            </a:r>
            <a:r>
              <a:rPr lang="en-US" altLang="ja-JP" sz="1400" dirty="0">
                <a:latin typeface="Symbol" panose="05050102010706020507" pitchFamily="18" charset="2"/>
                <a:cs typeface="Calibri" panose="020F0502020204030204" pitchFamily="34" charset="0"/>
              </a:rPr>
              <a:t>m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 and 5</a:t>
            </a:r>
            <a:r>
              <a:rPr lang="en-US" altLang="ja-JP" sz="1400" dirty="0">
                <a:latin typeface="Symbol" panose="05050102010706020507" pitchFamily="18" charset="2"/>
                <a:cs typeface="Calibri" panose="020F0502020204030204" pitchFamily="34" charset="0"/>
              </a:rPr>
              <a:t>m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, and their fluorescein intensities were measured in quadruplicate. P value among the data were calculated with one way ANOVA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97515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7544" y="1789417"/>
            <a:ext cx="4309278" cy="3231958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783987" y="1717737"/>
            <a:ext cx="3254477" cy="3352799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2929812" y="3256914"/>
            <a:ext cx="279919" cy="2519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7" name="直線矢印コネクタ 6"/>
          <p:cNvCxnSpPr/>
          <p:nvPr/>
        </p:nvCxnSpPr>
        <p:spPr>
          <a:xfrm flipV="1">
            <a:off x="3209731" y="1789417"/>
            <a:ext cx="2157813" cy="146749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/>
          <p:cNvCxnSpPr/>
          <p:nvPr/>
        </p:nvCxnSpPr>
        <p:spPr>
          <a:xfrm>
            <a:off x="3209731" y="3508840"/>
            <a:ext cx="2157813" cy="149001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1734826" y="5376072"/>
            <a:ext cx="794199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lagen gel droplets (30μl) were made on plastic plate as described </a:t>
            </a:r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in Materials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ethods, and PMA-stimulated neutrophils (1x10</a:t>
            </a:r>
            <a:r>
              <a:rPr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2ml of DMEM supplemented with 2% FBS were added on them. After 12 hour incubation, media were removed and NETs were visualized with SYTOX green (50nM) under the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microscope.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7C7EB55-317F-437D-B88B-5B842CA5912B}"/>
              </a:ext>
            </a:extLst>
          </p:cNvPr>
          <p:cNvSpPr txBox="1"/>
          <p:nvPr/>
        </p:nvSpPr>
        <p:spPr>
          <a:xfrm>
            <a:off x="653725" y="527821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5591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</TotalTime>
  <Words>459</Words>
  <Application>Microsoft Office PowerPoint</Application>
  <PresentationFormat>ワイド画面</PresentationFormat>
  <Paragraphs>20</Paragraphs>
  <Slides>4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游ゴシック</vt:lpstr>
      <vt:lpstr>游ゴシック Light</vt:lpstr>
      <vt:lpstr>Arial</vt:lpstr>
      <vt:lpstr>Calibri</vt:lpstr>
      <vt:lpstr>Symbol</vt:lpstr>
      <vt:lpstr>Times New Roman</vt:lpstr>
      <vt:lpstr>Office テーマ</vt:lpstr>
      <vt:lpstr>GraphPad Prism 8 Project</vt:lpstr>
      <vt:lpstr>Prism 8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tayama joji</dc:creator>
  <cp:lastModifiedBy>北山 丈二</cp:lastModifiedBy>
  <cp:revision>58</cp:revision>
  <dcterms:created xsi:type="dcterms:W3CDTF">2021-12-17T06:51:12Z</dcterms:created>
  <dcterms:modified xsi:type="dcterms:W3CDTF">2022-05-30T01:30:21Z</dcterms:modified>
</cp:coreProperties>
</file>